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943600" cy="8229600"/>
  <p:notesSz cx="6858000" cy="9144000"/>
  <p:defaultTextStyle>
    <a:defPPr>
      <a:defRPr lang="en-US"/>
    </a:defPPr>
    <a:lvl1pPr marL="0" algn="l" defTabSz="809884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04942" algn="l" defTabSz="809884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09884" algn="l" defTabSz="809884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14826" algn="l" defTabSz="809884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19768" algn="l" defTabSz="809884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24710" algn="l" defTabSz="809884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29652" algn="l" defTabSz="809884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834594" algn="l" defTabSz="809884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239536" algn="l" defTabSz="809884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-2580" y="-108"/>
      </p:cViewPr>
      <p:guideLst>
        <p:guide orient="horz" pos="2592"/>
        <p:guide pos="18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for_ray_june26_maf005_1mb_euchr!$E$1</c:f>
              <c:strCache>
                <c:ptCount val="1"/>
                <c:pt idx="0">
                  <c:v>r2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xVal>
            <c:numRef>
              <c:f>for_ray_june26_maf005_1mb_euchr!$D$2:$D$71</c:f>
              <c:numCache>
                <c:formatCode>General</c:formatCode>
                <c:ptCount val="70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  <c:pt idx="8">
                  <c:v>8.5</c:v>
                </c:pt>
                <c:pt idx="9">
                  <c:v>9.5</c:v>
                </c:pt>
                <c:pt idx="10">
                  <c:v>10.5</c:v>
                </c:pt>
                <c:pt idx="11">
                  <c:v>11.5</c:v>
                </c:pt>
                <c:pt idx="12">
                  <c:v>12.5</c:v>
                </c:pt>
                <c:pt idx="13">
                  <c:v>13.5</c:v>
                </c:pt>
                <c:pt idx="14">
                  <c:v>14.5</c:v>
                </c:pt>
                <c:pt idx="15">
                  <c:v>15.5</c:v>
                </c:pt>
                <c:pt idx="16">
                  <c:v>16.5</c:v>
                </c:pt>
                <c:pt idx="17">
                  <c:v>17.5</c:v>
                </c:pt>
                <c:pt idx="18">
                  <c:v>18.5</c:v>
                </c:pt>
                <c:pt idx="19">
                  <c:v>19.5</c:v>
                </c:pt>
                <c:pt idx="20">
                  <c:v>20.5</c:v>
                </c:pt>
                <c:pt idx="21">
                  <c:v>21.5</c:v>
                </c:pt>
                <c:pt idx="22">
                  <c:v>22.5</c:v>
                </c:pt>
                <c:pt idx="23">
                  <c:v>23.5</c:v>
                </c:pt>
                <c:pt idx="24">
                  <c:v>24.5</c:v>
                </c:pt>
                <c:pt idx="25">
                  <c:v>25.5</c:v>
                </c:pt>
                <c:pt idx="26">
                  <c:v>26.5</c:v>
                </c:pt>
                <c:pt idx="27">
                  <c:v>27.5</c:v>
                </c:pt>
                <c:pt idx="28">
                  <c:v>28.5</c:v>
                </c:pt>
                <c:pt idx="29">
                  <c:v>29.5</c:v>
                </c:pt>
                <c:pt idx="30">
                  <c:v>30.5</c:v>
                </c:pt>
                <c:pt idx="31">
                  <c:v>31.5</c:v>
                </c:pt>
                <c:pt idx="32">
                  <c:v>32.5</c:v>
                </c:pt>
                <c:pt idx="33">
                  <c:v>33.5</c:v>
                </c:pt>
                <c:pt idx="34">
                  <c:v>34.5</c:v>
                </c:pt>
                <c:pt idx="35">
                  <c:v>35.5</c:v>
                </c:pt>
                <c:pt idx="36">
                  <c:v>36.5</c:v>
                </c:pt>
                <c:pt idx="37">
                  <c:v>37.5</c:v>
                </c:pt>
                <c:pt idx="38">
                  <c:v>38.5</c:v>
                </c:pt>
                <c:pt idx="39">
                  <c:v>39.5</c:v>
                </c:pt>
                <c:pt idx="40">
                  <c:v>40.5</c:v>
                </c:pt>
                <c:pt idx="41">
                  <c:v>41.5</c:v>
                </c:pt>
                <c:pt idx="42">
                  <c:v>42.5</c:v>
                </c:pt>
                <c:pt idx="43">
                  <c:v>43.5</c:v>
                </c:pt>
                <c:pt idx="44">
                  <c:v>44.5</c:v>
                </c:pt>
                <c:pt idx="45">
                  <c:v>45.5</c:v>
                </c:pt>
                <c:pt idx="46">
                  <c:v>46.5</c:v>
                </c:pt>
                <c:pt idx="47">
                  <c:v>47.5</c:v>
                </c:pt>
                <c:pt idx="48">
                  <c:v>48.5</c:v>
                </c:pt>
                <c:pt idx="49">
                  <c:v>49.5</c:v>
                </c:pt>
                <c:pt idx="50">
                  <c:v>50.5</c:v>
                </c:pt>
                <c:pt idx="51">
                  <c:v>51.5</c:v>
                </c:pt>
                <c:pt idx="52">
                  <c:v>52.5</c:v>
                </c:pt>
                <c:pt idx="53">
                  <c:v>53.5</c:v>
                </c:pt>
                <c:pt idx="54">
                  <c:v>54.5</c:v>
                </c:pt>
                <c:pt idx="55">
                  <c:v>55.5</c:v>
                </c:pt>
                <c:pt idx="56">
                  <c:v>56.5</c:v>
                </c:pt>
                <c:pt idx="57">
                  <c:v>57.5</c:v>
                </c:pt>
                <c:pt idx="58">
                  <c:v>58.5</c:v>
                </c:pt>
                <c:pt idx="59">
                  <c:v>59.5</c:v>
                </c:pt>
                <c:pt idx="60">
                  <c:v>60.5</c:v>
                </c:pt>
                <c:pt idx="61">
                  <c:v>61.5</c:v>
                </c:pt>
                <c:pt idx="62">
                  <c:v>62.5</c:v>
                </c:pt>
                <c:pt idx="63">
                  <c:v>63.5</c:v>
                </c:pt>
                <c:pt idx="64">
                  <c:v>64.5</c:v>
                </c:pt>
                <c:pt idx="65">
                  <c:v>65.5</c:v>
                </c:pt>
                <c:pt idx="66">
                  <c:v>66.5</c:v>
                </c:pt>
                <c:pt idx="67">
                  <c:v>67.5</c:v>
                </c:pt>
                <c:pt idx="68">
                  <c:v>68.5</c:v>
                </c:pt>
                <c:pt idx="69">
                  <c:v>69.5</c:v>
                </c:pt>
              </c:numCache>
            </c:numRef>
          </c:xVal>
          <c:yVal>
            <c:numRef>
              <c:f>for_ray_june26_maf005_1mb_euchr!$E$2:$E$71</c:f>
              <c:numCache>
                <c:formatCode>General</c:formatCode>
                <c:ptCount val="70"/>
                <c:pt idx="0">
                  <c:v>0.66584214600000002</c:v>
                </c:pt>
                <c:pt idx="1">
                  <c:v>0.54739789900000002</c:v>
                </c:pt>
                <c:pt idx="2">
                  <c:v>0.49569691300000002</c:v>
                </c:pt>
                <c:pt idx="3">
                  <c:v>0.44785688299999998</c:v>
                </c:pt>
                <c:pt idx="4">
                  <c:v>0.41428757100000002</c:v>
                </c:pt>
                <c:pt idx="5">
                  <c:v>0.38994363700000001</c:v>
                </c:pt>
                <c:pt idx="6">
                  <c:v>0.36538925500000002</c:v>
                </c:pt>
                <c:pt idx="7">
                  <c:v>0.34591364299999999</c:v>
                </c:pt>
                <c:pt idx="8">
                  <c:v>0.32375250900000002</c:v>
                </c:pt>
                <c:pt idx="9">
                  <c:v>0.31473655499999997</c:v>
                </c:pt>
                <c:pt idx="10">
                  <c:v>0.29974764700000001</c:v>
                </c:pt>
                <c:pt idx="11">
                  <c:v>0.28624126999999999</c:v>
                </c:pt>
                <c:pt idx="12">
                  <c:v>0.27587964999999998</c:v>
                </c:pt>
                <c:pt idx="13">
                  <c:v>0.26368118099999999</c:v>
                </c:pt>
                <c:pt idx="14">
                  <c:v>0.256480614</c:v>
                </c:pt>
                <c:pt idx="15">
                  <c:v>0.246624858</c:v>
                </c:pt>
                <c:pt idx="16">
                  <c:v>0.24080095800000001</c:v>
                </c:pt>
                <c:pt idx="17">
                  <c:v>0.22560697199999999</c:v>
                </c:pt>
                <c:pt idx="18">
                  <c:v>0.212553768</c:v>
                </c:pt>
                <c:pt idx="19">
                  <c:v>0.198906473</c:v>
                </c:pt>
                <c:pt idx="20">
                  <c:v>0.20667417699999999</c:v>
                </c:pt>
                <c:pt idx="21">
                  <c:v>0.19016888400000001</c:v>
                </c:pt>
                <c:pt idx="22">
                  <c:v>0.197857546</c:v>
                </c:pt>
                <c:pt idx="23">
                  <c:v>0.18384630599999999</c:v>
                </c:pt>
                <c:pt idx="24">
                  <c:v>0.18349057799999999</c:v>
                </c:pt>
                <c:pt idx="25">
                  <c:v>0.19710261400000001</c:v>
                </c:pt>
                <c:pt idx="26">
                  <c:v>0.18565640999999999</c:v>
                </c:pt>
                <c:pt idx="27">
                  <c:v>0.178082713</c:v>
                </c:pt>
                <c:pt idx="28">
                  <c:v>0.165714847</c:v>
                </c:pt>
                <c:pt idx="29">
                  <c:v>0.18739078000000001</c:v>
                </c:pt>
                <c:pt idx="30">
                  <c:v>0.180707795</c:v>
                </c:pt>
                <c:pt idx="31">
                  <c:v>0.18683319300000001</c:v>
                </c:pt>
                <c:pt idx="32">
                  <c:v>0.15692636600000001</c:v>
                </c:pt>
                <c:pt idx="33">
                  <c:v>0.16945415599999999</c:v>
                </c:pt>
                <c:pt idx="34">
                  <c:v>0.15193540799999999</c:v>
                </c:pt>
                <c:pt idx="35">
                  <c:v>0.147378279</c:v>
                </c:pt>
                <c:pt idx="36">
                  <c:v>0.15299754800000001</c:v>
                </c:pt>
                <c:pt idx="37">
                  <c:v>0.18309550499999999</c:v>
                </c:pt>
                <c:pt idx="38">
                  <c:v>0.17791608</c:v>
                </c:pt>
                <c:pt idx="39">
                  <c:v>0.151195684</c:v>
                </c:pt>
                <c:pt idx="40">
                  <c:v>0.16373026500000001</c:v>
                </c:pt>
                <c:pt idx="41">
                  <c:v>0.12739472600000001</c:v>
                </c:pt>
                <c:pt idx="42">
                  <c:v>0.144492912</c:v>
                </c:pt>
                <c:pt idx="43">
                  <c:v>0.137270379</c:v>
                </c:pt>
                <c:pt idx="44">
                  <c:v>0.16368622299999999</c:v>
                </c:pt>
                <c:pt idx="45">
                  <c:v>0.123071314</c:v>
                </c:pt>
                <c:pt idx="46">
                  <c:v>0.16325822800000001</c:v>
                </c:pt>
                <c:pt idx="47">
                  <c:v>0.15737068400000001</c:v>
                </c:pt>
                <c:pt idx="48">
                  <c:v>0.162189104</c:v>
                </c:pt>
                <c:pt idx="49">
                  <c:v>0.20108862799999999</c:v>
                </c:pt>
                <c:pt idx="50">
                  <c:v>0.139831914</c:v>
                </c:pt>
                <c:pt idx="51">
                  <c:v>0.14180337500000001</c:v>
                </c:pt>
                <c:pt idx="52">
                  <c:v>0.11477506899999999</c:v>
                </c:pt>
                <c:pt idx="53">
                  <c:v>0.20244743500000001</c:v>
                </c:pt>
                <c:pt idx="54">
                  <c:v>0.17233314499999999</c:v>
                </c:pt>
                <c:pt idx="55">
                  <c:v>0.149487959</c:v>
                </c:pt>
                <c:pt idx="56">
                  <c:v>0.13302044900000001</c:v>
                </c:pt>
                <c:pt idx="57">
                  <c:v>0.22551207300000001</c:v>
                </c:pt>
                <c:pt idx="58">
                  <c:v>0.216469578</c:v>
                </c:pt>
                <c:pt idx="59">
                  <c:v>0.15610158599999999</c:v>
                </c:pt>
                <c:pt idx="60">
                  <c:v>0.14214528800000001</c:v>
                </c:pt>
                <c:pt idx="61">
                  <c:v>0.21645502599999999</c:v>
                </c:pt>
                <c:pt idx="62">
                  <c:v>7.8111446000000001E-2</c:v>
                </c:pt>
                <c:pt idx="63">
                  <c:v>0.22130854799999999</c:v>
                </c:pt>
                <c:pt idx="64">
                  <c:v>0.18081328199999999</c:v>
                </c:pt>
                <c:pt idx="65">
                  <c:v>0.16074195499999999</c:v>
                </c:pt>
                <c:pt idx="66">
                  <c:v>0.14617238399999999</c:v>
                </c:pt>
                <c:pt idx="67">
                  <c:v>0.15144623900000001</c:v>
                </c:pt>
                <c:pt idx="68">
                  <c:v>0.18716013400000001</c:v>
                </c:pt>
                <c:pt idx="69">
                  <c:v>0.14870680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9051904"/>
        <c:axId val="93081984"/>
      </c:scatterChart>
      <c:valAx>
        <c:axId val="890519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Distance (10kb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prstDash val="solid"/>
          </a:ln>
          <a:effectLst/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93081984"/>
        <c:crosses val="autoZero"/>
        <c:crossBetween val="midCat"/>
      </c:valAx>
      <c:valAx>
        <c:axId val="9308198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2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38100" cap="flat" cmpd="sng" algn="ctr">
            <a:solidFill>
              <a:schemeClr val="tx1"/>
            </a:solidFill>
            <a:prstDash val="solid"/>
          </a:ln>
          <a:effectLst/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8905190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for_ray_june26_maf005_1mb_heter!$E$1</c:f>
              <c:strCache>
                <c:ptCount val="1"/>
                <c:pt idx="0">
                  <c:v>r2</c:v>
                </c:pt>
              </c:strCache>
            </c:strRef>
          </c:tx>
          <c:spPr>
            <a:ln w="28575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for_ray_june26_maf005_1mb_heter!$D$2:$D$100</c:f>
              <c:numCache>
                <c:formatCode>General</c:formatCode>
                <c:ptCount val="99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  <c:pt idx="8">
                  <c:v>8.5</c:v>
                </c:pt>
                <c:pt idx="9">
                  <c:v>9.5</c:v>
                </c:pt>
                <c:pt idx="10">
                  <c:v>10.5</c:v>
                </c:pt>
                <c:pt idx="11">
                  <c:v>11.5</c:v>
                </c:pt>
                <c:pt idx="12">
                  <c:v>12.5</c:v>
                </c:pt>
                <c:pt idx="13">
                  <c:v>13.5</c:v>
                </c:pt>
                <c:pt idx="14">
                  <c:v>14.5</c:v>
                </c:pt>
                <c:pt idx="15">
                  <c:v>15.5</c:v>
                </c:pt>
                <c:pt idx="16">
                  <c:v>16.5</c:v>
                </c:pt>
                <c:pt idx="17">
                  <c:v>17.5</c:v>
                </c:pt>
                <c:pt idx="18">
                  <c:v>18.5</c:v>
                </c:pt>
                <c:pt idx="19">
                  <c:v>19.5</c:v>
                </c:pt>
                <c:pt idx="20">
                  <c:v>20.5</c:v>
                </c:pt>
                <c:pt idx="21">
                  <c:v>21.5</c:v>
                </c:pt>
                <c:pt idx="22">
                  <c:v>22.5</c:v>
                </c:pt>
                <c:pt idx="23">
                  <c:v>23.5</c:v>
                </c:pt>
                <c:pt idx="24">
                  <c:v>24.5</c:v>
                </c:pt>
                <c:pt idx="25">
                  <c:v>25.5</c:v>
                </c:pt>
                <c:pt idx="26">
                  <c:v>26.5</c:v>
                </c:pt>
                <c:pt idx="27">
                  <c:v>27.5</c:v>
                </c:pt>
                <c:pt idx="28">
                  <c:v>28.5</c:v>
                </c:pt>
                <c:pt idx="29">
                  <c:v>29.5</c:v>
                </c:pt>
                <c:pt idx="30">
                  <c:v>30.5</c:v>
                </c:pt>
                <c:pt idx="31">
                  <c:v>31.5</c:v>
                </c:pt>
                <c:pt idx="32">
                  <c:v>32.5</c:v>
                </c:pt>
                <c:pt idx="33">
                  <c:v>33.5</c:v>
                </c:pt>
                <c:pt idx="34">
                  <c:v>34.5</c:v>
                </c:pt>
                <c:pt idx="35">
                  <c:v>35.5</c:v>
                </c:pt>
                <c:pt idx="36">
                  <c:v>36.5</c:v>
                </c:pt>
                <c:pt idx="37">
                  <c:v>37.5</c:v>
                </c:pt>
                <c:pt idx="38">
                  <c:v>38.5</c:v>
                </c:pt>
                <c:pt idx="39">
                  <c:v>39.5</c:v>
                </c:pt>
                <c:pt idx="40">
                  <c:v>40.5</c:v>
                </c:pt>
                <c:pt idx="41">
                  <c:v>41.5</c:v>
                </c:pt>
                <c:pt idx="42">
                  <c:v>42.5</c:v>
                </c:pt>
                <c:pt idx="43">
                  <c:v>43.5</c:v>
                </c:pt>
                <c:pt idx="44">
                  <c:v>44.5</c:v>
                </c:pt>
                <c:pt idx="45">
                  <c:v>45.5</c:v>
                </c:pt>
                <c:pt idx="46">
                  <c:v>46.5</c:v>
                </c:pt>
                <c:pt idx="47">
                  <c:v>47.5</c:v>
                </c:pt>
                <c:pt idx="48">
                  <c:v>48.5</c:v>
                </c:pt>
                <c:pt idx="49">
                  <c:v>49.5</c:v>
                </c:pt>
                <c:pt idx="50">
                  <c:v>50.5</c:v>
                </c:pt>
                <c:pt idx="51">
                  <c:v>51.5</c:v>
                </c:pt>
                <c:pt idx="52">
                  <c:v>52.5</c:v>
                </c:pt>
                <c:pt idx="53">
                  <c:v>53.5</c:v>
                </c:pt>
                <c:pt idx="54">
                  <c:v>54.5</c:v>
                </c:pt>
                <c:pt idx="55">
                  <c:v>55.5</c:v>
                </c:pt>
                <c:pt idx="56">
                  <c:v>56.5</c:v>
                </c:pt>
                <c:pt idx="57">
                  <c:v>57.5</c:v>
                </c:pt>
                <c:pt idx="58">
                  <c:v>58.5</c:v>
                </c:pt>
                <c:pt idx="59">
                  <c:v>59.5</c:v>
                </c:pt>
                <c:pt idx="60">
                  <c:v>60.5</c:v>
                </c:pt>
                <c:pt idx="61">
                  <c:v>61.5</c:v>
                </c:pt>
                <c:pt idx="62">
                  <c:v>62.5</c:v>
                </c:pt>
                <c:pt idx="63">
                  <c:v>63.5</c:v>
                </c:pt>
                <c:pt idx="64">
                  <c:v>64.5</c:v>
                </c:pt>
                <c:pt idx="65">
                  <c:v>65.5</c:v>
                </c:pt>
                <c:pt idx="66">
                  <c:v>66.5</c:v>
                </c:pt>
                <c:pt idx="67">
                  <c:v>67.5</c:v>
                </c:pt>
                <c:pt idx="68">
                  <c:v>68.5</c:v>
                </c:pt>
                <c:pt idx="69">
                  <c:v>69.5</c:v>
                </c:pt>
                <c:pt idx="70">
                  <c:v>70.5</c:v>
                </c:pt>
                <c:pt idx="71">
                  <c:v>71.5</c:v>
                </c:pt>
                <c:pt idx="72">
                  <c:v>72.5</c:v>
                </c:pt>
                <c:pt idx="73">
                  <c:v>73.5</c:v>
                </c:pt>
                <c:pt idx="74">
                  <c:v>74.5</c:v>
                </c:pt>
                <c:pt idx="75">
                  <c:v>75.5</c:v>
                </c:pt>
                <c:pt idx="76">
                  <c:v>76.5</c:v>
                </c:pt>
                <c:pt idx="77">
                  <c:v>77.5</c:v>
                </c:pt>
                <c:pt idx="78">
                  <c:v>78.5</c:v>
                </c:pt>
                <c:pt idx="79">
                  <c:v>79.5</c:v>
                </c:pt>
                <c:pt idx="80">
                  <c:v>80.5</c:v>
                </c:pt>
                <c:pt idx="81">
                  <c:v>81.5</c:v>
                </c:pt>
                <c:pt idx="82">
                  <c:v>82.5</c:v>
                </c:pt>
                <c:pt idx="83">
                  <c:v>83.5</c:v>
                </c:pt>
                <c:pt idx="84">
                  <c:v>84.5</c:v>
                </c:pt>
                <c:pt idx="85">
                  <c:v>85.5</c:v>
                </c:pt>
                <c:pt idx="86">
                  <c:v>86.5</c:v>
                </c:pt>
                <c:pt idx="87">
                  <c:v>87.5</c:v>
                </c:pt>
                <c:pt idx="88">
                  <c:v>88.5</c:v>
                </c:pt>
                <c:pt idx="89">
                  <c:v>89.5</c:v>
                </c:pt>
                <c:pt idx="90">
                  <c:v>90.5</c:v>
                </c:pt>
                <c:pt idx="91">
                  <c:v>91.5</c:v>
                </c:pt>
                <c:pt idx="92">
                  <c:v>92.5</c:v>
                </c:pt>
                <c:pt idx="93">
                  <c:v>93.5</c:v>
                </c:pt>
                <c:pt idx="94">
                  <c:v>94.5</c:v>
                </c:pt>
                <c:pt idx="95">
                  <c:v>95.5</c:v>
                </c:pt>
                <c:pt idx="96">
                  <c:v>96.5</c:v>
                </c:pt>
                <c:pt idx="97">
                  <c:v>97.5</c:v>
                </c:pt>
                <c:pt idx="98">
                  <c:v>98.5</c:v>
                </c:pt>
              </c:numCache>
            </c:numRef>
          </c:xVal>
          <c:yVal>
            <c:numRef>
              <c:f>for_ray_june26_maf005_1mb_heter!$E$2:$E$100</c:f>
              <c:numCache>
                <c:formatCode>General</c:formatCode>
                <c:ptCount val="99"/>
                <c:pt idx="0">
                  <c:v>0.72867199999999999</c:v>
                </c:pt>
                <c:pt idx="1">
                  <c:v>0.80519298399999994</c:v>
                </c:pt>
                <c:pt idx="2">
                  <c:v>0.730953878</c:v>
                </c:pt>
                <c:pt idx="3">
                  <c:v>0.69247937800000003</c:v>
                </c:pt>
                <c:pt idx="4">
                  <c:v>0.68828008399999996</c:v>
                </c:pt>
                <c:pt idx="5">
                  <c:v>0.63947252099999996</c:v>
                </c:pt>
                <c:pt idx="6">
                  <c:v>0.68843161200000003</c:v>
                </c:pt>
                <c:pt idx="7">
                  <c:v>0.63403171000000003</c:v>
                </c:pt>
                <c:pt idx="8">
                  <c:v>0.62402045100000003</c:v>
                </c:pt>
                <c:pt idx="9">
                  <c:v>0.63986899600000002</c:v>
                </c:pt>
                <c:pt idx="10">
                  <c:v>0.64063993299999999</c:v>
                </c:pt>
                <c:pt idx="11">
                  <c:v>0.62506104900000004</c:v>
                </c:pt>
                <c:pt idx="12">
                  <c:v>0.64099114099999999</c:v>
                </c:pt>
                <c:pt idx="13">
                  <c:v>0.60540095599999999</c:v>
                </c:pt>
                <c:pt idx="14">
                  <c:v>0.62437314399999999</c:v>
                </c:pt>
                <c:pt idx="15">
                  <c:v>0.62477135299999997</c:v>
                </c:pt>
                <c:pt idx="16">
                  <c:v>0.59775004899999995</c:v>
                </c:pt>
                <c:pt idx="17">
                  <c:v>0.58914963499999995</c:v>
                </c:pt>
                <c:pt idx="18">
                  <c:v>0.60681781199999996</c:v>
                </c:pt>
                <c:pt idx="19">
                  <c:v>0.60293446100000003</c:v>
                </c:pt>
                <c:pt idx="20">
                  <c:v>0.55761638000000002</c:v>
                </c:pt>
                <c:pt idx="21">
                  <c:v>0.57904093899999998</c:v>
                </c:pt>
                <c:pt idx="22">
                  <c:v>0.608441287</c:v>
                </c:pt>
                <c:pt idx="23">
                  <c:v>0.54150846900000005</c:v>
                </c:pt>
                <c:pt idx="24">
                  <c:v>0.56145030100000004</c:v>
                </c:pt>
                <c:pt idx="25">
                  <c:v>0.56591977000000004</c:v>
                </c:pt>
                <c:pt idx="26">
                  <c:v>0.58365629500000005</c:v>
                </c:pt>
                <c:pt idx="27">
                  <c:v>0.56325218799999999</c:v>
                </c:pt>
                <c:pt idx="28">
                  <c:v>0.60440360699999995</c:v>
                </c:pt>
                <c:pt idx="29">
                  <c:v>0.55448239099999996</c:v>
                </c:pt>
                <c:pt idx="30">
                  <c:v>0.54145575700000004</c:v>
                </c:pt>
                <c:pt idx="31">
                  <c:v>0.55293278300000004</c:v>
                </c:pt>
                <c:pt idx="32">
                  <c:v>0.54356044000000003</c:v>
                </c:pt>
                <c:pt idx="33">
                  <c:v>0.57367164699999995</c:v>
                </c:pt>
                <c:pt idx="34">
                  <c:v>0.54521684199999998</c:v>
                </c:pt>
                <c:pt idx="35">
                  <c:v>0.55669087900000003</c:v>
                </c:pt>
                <c:pt idx="36">
                  <c:v>0.53931779199999996</c:v>
                </c:pt>
                <c:pt idx="37">
                  <c:v>0.52502943000000002</c:v>
                </c:pt>
                <c:pt idx="38">
                  <c:v>0.53094478700000003</c:v>
                </c:pt>
                <c:pt idx="39">
                  <c:v>0.54085333300000005</c:v>
                </c:pt>
                <c:pt idx="40">
                  <c:v>0.55417484299999997</c:v>
                </c:pt>
                <c:pt idx="41">
                  <c:v>0.52396354599999995</c:v>
                </c:pt>
                <c:pt idx="42">
                  <c:v>0.50253291</c:v>
                </c:pt>
                <c:pt idx="43">
                  <c:v>0.55750472799999995</c:v>
                </c:pt>
                <c:pt idx="44">
                  <c:v>0.54143669999999999</c:v>
                </c:pt>
                <c:pt idx="45">
                  <c:v>0.50996726599999997</c:v>
                </c:pt>
                <c:pt idx="46">
                  <c:v>0.587506101</c:v>
                </c:pt>
                <c:pt idx="47">
                  <c:v>0.51583762099999997</c:v>
                </c:pt>
                <c:pt idx="48">
                  <c:v>0.51237747700000003</c:v>
                </c:pt>
                <c:pt idx="49">
                  <c:v>0.54588694900000001</c:v>
                </c:pt>
                <c:pt idx="50">
                  <c:v>0.54312722800000002</c:v>
                </c:pt>
                <c:pt idx="51">
                  <c:v>0.51256537099999999</c:v>
                </c:pt>
                <c:pt idx="52">
                  <c:v>0.49517070499999999</c:v>
                </c:pt>
                <c:pt idx="53">
                  <c:v>0.48467479200000002</c:v>
                </c:pt>
                <c:pt idx="54">
                  <c:v>0.53173085399999998</c:v>
                </c:pt>
                <c:pt idx="55">
                  <c:v>0.51359534799999995</c:v>
                </c:pt>
                <c:pt idx="56">
                  <c:v>0.52980853500000002</c:v>
                </c:pt>
                <c:pt idx="57">
                  <c:v>0.51295065799999995</c:v>
                </c:pt>
                <c:pt idx="58">
                  <c:v>0.52206399999999997</c:v>
                </c:pt>
                <c:pt idx="59">
                  <c:v>0.50998811799999999</c:v>
                </c:pt>
                <c:pt idx="60">
                  <c:v>0.51709159199999999</c:v>
                </c:pt>
                <c:pt idx="61">
                  <c:v>0.51740601500000005</c:v>
                </c:pt>
                <c:pt idx="62">
                  <c:v>0.50874622400000002</c:v>
                </c:pt>
                <c:pt idx="63">
                  <c:v>0.49417502299999999</c:v>
                </c:pt>
                <c:pt idx="64">
                  <c:v>0.442417281</c:v>
                </c:pt>
                <c:pt idx="65">
                  <c:v>0.48685147099999998</c:v>
                </c:pt>
                <c:pt idx="66">
                  <c:v>0.52533191300000004</c:v>
                </c:pt>
                <c:pt idx="67">
                  <c:v>0.501925328</c:v>
                </c:pt>
                <c:pt idx="68">
                  <c:v>0.50962740799999995</c:v>
                </c:pt>
                <c:pt idx="69">
                  <c:v>0.50315814800000003</c:v>
                </c:pt>
                <c:pt idx="70">
                  <c:v>0.49760959599999999</c:v>
                </c:pt>
                <c:pt idx="71">
                  <c:v>0.53459481099999995</c:v>
                </c:pt>
                <c:pt idx="72">
                  <c:v>0.46805227500000002</c:v>
                </c:pt>
                <c:pt idx="73">
                  <c:v>0.49720778599999998</c:v>
                </c:pt>
                <c:pt idx="74">
                  <c:v>0.52139496500000004</c:v>
                </c:pt>
                <c:pt idx="75">
                  <c:v>0.48678328100000001</c:v>
                </c:pt>
                <c:pt idx="76">
                  <c:v>0.44746170400000002</c:v>
                </c:pt>
                <c:pt idx="77">
                  <c:v>0.48312833999999999</c:v>
                </c:pt>
                <c:pt idx="78">
                  <c:v>0.47841254500000002</c:v>
                </c:pt>
                <c:pt idx="79">
                  <c:v>0.52756366300000002</c:v>
                </c:pt>
                <c:pt idx="80">
                  <c:v>0.44717543199999998</c:v>
                </c:pt>
                <c:pt idx="81">
                  <c:v>0.47691445199999999</c:v>
                </c:pt>
                <c:pt idx="82">
                  <c:v>0.50463187799999998</c:v>
                </c:pt>
                <c:pt idx="83">
                  <c:v>0.459118364</c:v>
                </c:pt>
                <c:pt idx="84">
                  <c:v>0.415113238</c:v>
                </c:pt>
                <c:pt idx="85">
                  <c:v>0.50844172399999998</c:v>
                </c:pt>
                <c:pt idx="86">
                  <c:v>0.50588506099999997</c:v>
                </c:pt>
                <c:pt idx="87">
                  <c:v>0.44329890100000002</c:v>
                </c:pt>
                <c:pt idx="88">
                  <c:v>0.42048298499999998</c:v>
                </c:pt>
                <c:pt idx="89">
                  <c:v>0.47024233599999998</c:v>
                </c:pt>
                <c:pt idx="90">
                  <c:v>0.497330575</c:v>
                </c:pt>
                <c:pt idx="91">
                  <c:v>0.41680901799999998</c:v>
                </c:pt>
                <c:pt idx="92">
                  <c:v>0.44350186400000002</c:v>
                </c:pt>
                <c:pt idx="93">
                  <c:v>0.51232105999999999</c:v>
                </c:pt>
                <c:pt idx="94">
                  <c:v>0.44786762899999999</c:v>
                </c:pt>
                <c:pt idx="95">
                  <c:v>0.44432185000000002</c:v>
                </c:pt>
                <c:pt idx="96">
                  <c:v>0.50276467499999999</c:v>
                </c:pt>
                <c:pt idx="97">
                  <c:v>0.43034292499999999</c:v>
                </c:pt>
                <c:pt idx="98">
                  <c:v>0.4240993330000000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876224"/>
        <c:axId val="97922432"/>
      </c:scatterChart>
      <c:valAx>
        <c:axId val="97876224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 dirty="0" smtClean="0"/>
                  <a:t>Distance (</a:t>
                </a:r>
                <a:r>
                  <a:rPr lang="en-US" sz="1600" dirty="0"/>
                  <a:t>10kb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ln w="38100">
            <a:solidFill>
              <a:schemeClr val="tx1"/>
            </a:solidFill>
          </a:ln>
        </c:spPr>
        <c:crossAx val="97922432"/>
        <c:crosses val="autoZero"/>
        <c:crossBetween val="midCat"/>
      </c:valAx>
      <c:valAx>
        <c:axId val="9792243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2</a:t>
                </a:r>
              </a:p>
            </c:rich>
          </c:tx>
          <c:layout/>
          <c:overlay val="0"/>
        </c:title>
        <c:numFmt formatCode="#,##0.0" sourceLinked="0"/>
        <c:majorTickMark val="none"/>
        <c:minorTickMark val="none"/>
        <c:tickLblPos val="nextTo"/>
        <c:spPr>
          <a:ln w="38100">
            <a:solidFill>
              <a:schemeClr val="tx1"/>
            </a:solidFill>
          </a:ln>
        </c:spPr>
        <c:crossAx val="97876224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2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45770" y="2556512"/>
            <a:ext cx="5052060" cy="17640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1540" y="4663440"/>
            <a:ext cx="416052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49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098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148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197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247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296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345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395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8224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938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31832" y="440056"/>
            <a:ext cx="1002983" cy="93611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2885" y="440056"/>
            <a:ext cx="2909888" cy="93611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3058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1748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9504" y="5288280"/>
            <a:ext cx="5052060" cy="1634490"/>
          </a:xfrm>
        </p:spPr>
        <p:txBody>
          <a:bodyPr anchor="t"/>
          <a:lstStyle>
            <a:lvl1pPr algn="l">
              <a:defRPr sz="35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9504" y="3488057"/>
            <a:ext cx="5052060" cy="1800224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0494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0988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148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6197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202471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42965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83459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23953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5413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2885" y="2560320"/>
            <a:ext cx="1956435" cy="724090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78380" y="2560320"/>
            <a:ext cx="1956435" cy="724090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5050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180" y="329566"/>
            <a:ext cx="534924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181" y="1842135"/>
            <a:ext cx="2626122" cy="767714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4942" indent="0">
              <a:buNone/>
              <a:defRPr sz="1800" b="1"/>
            </a:lvl2pPr>
            <a:lvl3pPr marL="809884" indent="0">
              <a:buNone/>
              <a:defRPr sz="1600" b="1"/>
            </a:lvl3pPr>
            <a:lvl4pPr marL="1214826" indent="0">
              <a:buNone/>
              <a:defRPr sz="1400" b="1"/>
            </a:lvl4pPr>
            <a:lvl5pPr marL="1619768" indent="0">
              <a:buNone/>
              <a:defRPr sz="1400" b="1"/>
            </a:lvl5pPr>
            <a:lvl6pPr marL="2024710" indent="0">
              <a:buNone/>
              <a:defRPr sz="1400" b="1"/>
            </a:lvl6pPr>
            <a:lvl7pPr marL="2429652" indent="0">
              <a:buNone/>
              <a:defRPr sz="1400" b="1"/>
            </a:lvl7pPr>
            <a:lvl8pPr marL="2834594" indent="0">
              <a:buNone/>
              <a:defRPr sz="1400" b="1"/>
            </a:lvl8pPr>
            <a:lvl9pPr marL="3239536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181" y="2609850"/>
            <a:ext cx="2626122" cy="474154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19267" y="1842135"/>
            <a:ext cx="2627154" cy="767714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4942" indent="0">
              <a:buNone/>
              <a:defRPr sz="1800" b="1"/>
            </a:lvl2pPr>
            <a:lvl3pPr marL="809884" indent="0">
              <a:buNone/>
              <a:defRPr sz="1600" b="1"/>
            </a:lvl3pPr>
            <a:lvl4pPr marL="1214826" indent="0">
              <a:buNone/>
              <a:defRPr sz="1400" b="1"/>
            </a:lvl4pPr>
            <a:lvl5pPr marL="1619768" indent="0">
              <a:buNone/>
              <a:defRPr sz="1400" b="1"/>
            </a:lvl5pPr>
            <a:lvl6pPr marL="2024710" indent="0">
              <a:buNone/>
              <a:defRPr sz="1400" b="1"/>
            </a:lvl6pPr>
            <a:lvl7pPr marL="2429652" indent="0">
              <a:buNone/>
              <a:defRPr sz="1400" b="1"/>
            </a:lvl7pPr>
            <a:lvl8pPr marL="2834594" indent="0">
              <a:buNone/>
              <a:defRPr sz="1400" b="1"/>
            </a:lvl8pPr>
            <a:lvl9pPr marL="3239536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19267" y="2609850"/>
            <a:ext cx="2627154" cy="474154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568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3627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6214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180" y="327660"/>
            <a:ext cx="1955404" cy="13944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23782" y="327661"/>
            <a:ext cx="3322638" cy="7023736"/>
          </a:xfrm>
        </p:spPr>
        <p:txBody>
          <a:bodyPr/>
          <a:lstStyle>
            <a:lvl1pPr>
              <a:defRPr sz="2800"/>
            </a:lvl1pPr>
            <a:lvl2pPr>
              <a:defRPr sz="25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180" y="1722121"/>
            <a:ext cx="1955404" cy="5629276"/>
          </a:xfrm>
        </p:spPr>
        <p:txBody>
          <a:bodyPr/>
          <a:lstStyle>
            <a:lvl1pPr marL="0" indent="0">
              <a:buNone/>
              <a:defRPr sz="1200"/>
            </a:lvl1pPr>
            <a:lvl2pPr marL="404942" indent="0">
              <a:buNone/>
              <a:defRPr sz="1100"/>
            </a:lvl2pPr>
            <a:lvl3pPr marL="809884" indent="0">
              <a:buNone/>
              <a:defRPr sz="900"/>
            </a:lvl3pPr>
            <a:lvl4pPr marL="1214826" indent="0">
              <a:buNone/>
              <a:defRPr sz="800"/>
            </a:lvl4pPr>
            <a:lvl5pPr marL="1619768" indent="0">
              <a:buNone/>
              <a:defRPr sz="800"/>
            </a:lvl5pPr>
            <a:lvl6pPr marL="2024710" indent="0">
              <a:buNone/>
              <a:defRPr sz="800"/>
            </a:lvl6pPr>
            <a:lvl7pPr marL="2429652" indent="0">
              <a:buNone/>
              <a:defRPr sz="800"/>
            </a:lvl7pPr>
            <a:lvl8pPr marL="2834594" indent="0">
              <a:buNone/>
              <a:defRPr sz="800"/>
            </a:lvl8pPr>
            <a:lvl9pPr marL="3239536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5973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4987" y="5760720"/>
            <a:ext cx="3566160" cy="680086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64987" y="735330"/>
            <a:ext cx="3566160" cy="4937760"/>
          </a:xfrm>
        </p:spPr>
        <p:txBody>
          <a:bodyPr/>
          <a:lstStyle>
            <a:lvl1pPr marL="0" indent="0">
              <a:buNone/>
              <a:defRPr sz="2800"/>
            </a:lvl1pPr>
            <a:lvl2pPr marL="404942" indent="0">
              <a:buNone/>
              <a:defRPr sz="2500"/>
            </a:lvl2pPr>
            <a:lvl3pPr marL="809884" indent="0">
              <a:buNone/>
              <a:defRPr sz="2100"/>
            </a:lvl3pPr>
            <a:lvl4pPr marL="1214826" indent="0">
              <a:buNone/>
              <a:defRPr sz="1800"/>
            </a:lvl4pPr>
            <a:lvl5pPr marL="1619768" indent="0">
              <a:buNone/>
              <a:defRPr sz="1800"/>
            </a:lvl5pPr>
            <a:lvl6pPr marL="2024710" indent="0">
              <a:buNone/>
              <a:defRPr sz="1800"/>
            </a:lvl6pPr>
            <a:lvl7pPr marL="2429652" indent="0">
              <a:buNone/>
              <a:defRPr sz="1800"/>
            </a:lvl7pPr>
            <a:lvl8pPr marL="2834594" indent="0">
              <a:buNone/>
              <a:defRPr sz="1800"/>
            </a:lvl8pPr>
            <a:lvl9pPr marL="3239536" indent="0">
              <a:buNone/>
              <a:defRPr sz="18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4987" y="6440806"/>
            <a:ext cx="3566160" cy="965834"/>
          </a:xfrm>
        </p:spPr>
        <p:txBody>
          <a:bodyPr/>
          <a:lstStyle>
            <a:lvl1pPr marL="0" indent="0">
              <a:buNone/>
              <a:defRPr sz="1200"/>
            </a:lvl1pPr>
            <a:lvl2pPr marL="404942" indent="0">
              <a:buNone/>
              <a:defRPr sz="1100"/>
            </a:lvl2pPr>
            <a:lvl3pPr marL="809884" indent="0">
              <a:buNone/>
              <a:defRPr sz="900"/>
            </a:lvl3pPr>
            <a:lvl4pPr marL="1214826" indent="0">
              <a:buNone/>
              <a:defRPr sz="800"/>
            </a:lvl4pPr>
            <a:lvl5pPr marL="1619768" indent="0">
              <a:buNone/>
              <a:defRPr sz="800"/>
            </a:lvl5pPr>
            <a:lvl6pPr marL="2024710" indent="0">
              <a:buNone/>
              <a:defRPr sz="800"/>
            </a:lvl6pPr>
            <a:lvl7pPr marL="2429652" indent="0">
              <a:buNone/>
              <a:defRPr sz="800"/>
            </a:lvl7pPr>
            <a:lvl8pPr marL="2834594" indent="0">
              <a:buNone/>
              <a:defRPr sz="800"/>
            </a:lvl8pPr>
            <a:lvl9pPr marL="3239536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052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7180" y="329566"/>
            <a:ext cx="5349240" cy="1371600"/>
          </a:xfrm>
          <a:prstGeom prst="rect">
            <a:avLst/>
          </a:prstGeom>
        </p:spPr>
        <p:txBody>
          <a:bodyPr vert="horz" lIns="80988" tIns="40494" rIns="80988" bIns="40494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180" y="1920242"/>
            <a:ext cx="5349240" cy="5431155"/>
          </a:xfrm>
          <a:prstGeom prst="rect">
            <a:avLst/>
          </a:prstGeom>
        </p:spPr>
        <p:txBody>
          <a:bodyPr vert="horz" lIns="80988" tIns="40494" rIns="80988" bIns="4049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180" y="7627621"/>
            <a:ext cx="1386840" cy="438150"/>
          </a:xfrm>
          <a:prstGeom prst="rect">
            <a:avLst/>
          </a:prstGeom>
        </p:spPr>
        <p:txBody>
          <a:bodyPr vert="horz" lIns="80988" tIns="40494" rIns="80988" bIns="40494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A900B4-559F-4375-AEA8-07102B3A0BE0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30730" y="7627621"/>
            <a:ext cx="1882140" cy="438150"/>
          </a:xfrm>
          <a:prstGeom prst="rect">
            <a:avLst/>
          </a:prstGeom>
        </p:spPr>
        <p:txBody>
          <a:bodyPr vert="horz" lIns="80988" tIns="40494" rIns="80988" bIns="40494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259580" y="7627621"/>
            <a:ext cx="1386840" cy="438150"/>
          </a:xfrm>
          <a:prstGeom prst="rect">
            <a:avLst/>
          </a:prstGeom>
        </p:spPr>
        <p:txBody>
          <a:bodyPr vert="horz" lIns="80988" tIns="40494" rIns="80988" bIns="40494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CAC109-14B1-4260-9FFE-7E8CD34A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4111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09884" rtl="0" eaLnBrk="1" latinLnBrk="0" hangingPunct="1">
        <a:spcBef>
          <a:spcPct val="0"/>
        </a:spcBef>
        <a:buNone/>
        <a:defRPr sz="3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3707" indent="-303707" algn="l" defTabSz="80988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58031" indent="-253089" algn="l" defTabSz="809884" rtl="0" eaLnBrk="1" latinLnBrk="0" hangingPunct="1">
        <a:spcBef>
          <a:spcPct val="20000"/>
        </a:spcBef>
        <a:buFont typeface="Arial" panose="020B0604020202020204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12355" indent="-202471" algn="l" defTabSz="809884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417297" indent="-202471" algn="l" defTabSz="809884" rtl="0" eaLnBrk="1" latinLnBrk="0" hangingPunct="1">
        <a:spcBef>
          <a:spcPct val="20000"/>
        </a:spcBef>
        <a:buFont typeface="Arial" panose="020B0604020202020204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2239" indent="-202471" algn="l" defTabSz="809884" rtl="0" eaLnBrk="1" latinLnBrk="0" hangingPunct="1">
        <a:spcBef>
          <a:spcPct val="20000"/>
        </a:spcBef>
        <a:buFont typeface="Arial" panose="020B0604020202020204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27181" indent="-202471" algn="l" defTabSz="809884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32123" indent="-202471" algn="l" defTabSz="809884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37065" indent="-202471" algn="l" defTabSz="809884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42007" indent="-202471" algn="l" defTabSz="809884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09884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4942" algn="l" defTabSz="809884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09884" algn="l" defTabSz="809884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14826" algn="l" defTabSz="809884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768" algn="l" defTabSz="809884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24710" algn="l" defTabSz="809884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29652" algn="l" defTabSz="809884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34594" algn="l" defTabSz="809884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39536" algn="l" defTabSz="809884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6245299"/>
              </p:ext>
            </p:extLst>
          </p:nvPr>
        </p:nvGraphicFramePr>
        <p:xfrm>
          <a:off x="434789" y="685800"/>
          <a:ext cx="5124450" cy="3057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2683549"/>
              </p:ext>
            </p:extLst>
          </p:nvPr>
        </p:nvGraphicFramePr>
        <p:xfrm>
          <a:off x="434790" y="4038600"/>
          <a:ext cx="5181600" cy="29670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663389" y="7239000"/>
            <a:ext cx="5029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 Fig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tent of LD decay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uchromat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) and heterochromatic region (b) with a 1 Mb window and using 31,253 SNP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04800" y="367304"/>
            <a:ext cx="505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"/>
          <p:cNvSpPr txBox="1"/>
          <p:nvPr/>
        </p:nvSpPr>
        <p:spPr>
          <a:xfrm>
            <a:off x="304800" y="3733800"/>
            <a:ext cx="5052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GB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8986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napal, Arun P.</dc:creator>
  <cp:lastModifiedBy>Dhanapal, Arun P.</cp:lastModifiedBy>
  <cp:revision>1</cp:revision>
  <dcterms:created xsi:type="dcterms:W3CDTF">2015-08-07T21:51:30Z</dcterms:created>
  <dcterms:modified xsi:type="dcterms:W3CDTF">2015-08-07T21:52:51Z</dcterms:modified>
</cp:coreProperties>
</file>